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1EA003-FFBD-4C07-BFC9-89D34FC2E1E8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2296EC-6F59-4B2B-A122-FF098F3CC7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468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2296EC-6F59-4B2B-A122-FF098F3CC7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62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4537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007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253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730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26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780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23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048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69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585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392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20F14-5692-49D0-A8F6-DC5E69B41F72}" type="datetimeFigureOut">
              <a:rPr lang="en-US" smtClean="0"/>
              <a:t>8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3DAA4D-96F0-4C6E-8D33-FB1BCAF62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35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ounded Rectangle 11"/>
          <p:cNvSpPr/>
          <p:nvPr/>
        </p:nvSpPr>
        <p:spPr>
          <a:xfrm>
            <a:off x="457203" y="2260226"/>
            <a:ext cx="3843590" cy="609186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eld experiment in multiple environments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ounded Rectangle 26"/>
          <p:cNvSpPr/>
          <p:nvPr/>
        </p:nvSpPr>
        <p:spPr>
          <a:xfrm>
            <a:off x="4571070" y="2279301"/>
            <a:ext cx="3887130" cy="590111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otyping with SoySNP50k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adChip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52,041 SNP)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ounded Rectangle 18"/>
          <p:cNvSpPr/>
          <p:nvPr/>
        </p:nvSpPr>
        <p:spPr>
          <a:xfrm>
            <a:off x="5867399" y="4320307"/>
            <a:ext cx="2586135" cy="614290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lective sweep analysis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ounded Rectangle 35"/>
          <p:cNvSpPr/>
          <p:nvPr/>
        </p:nvSpPr>
        <p:spPr>
          <a:xfrm>
            <a:off x="457203" y="4320307"/>
            <a:ext cx="3657600" cy="614290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ome wide association mapping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smtClean="0">
                <a:ln w="18000">
                  <a:solidFill>
                    <a:schemeClr val="accent2">
                      <a:satMod val="140000"/>
                    </a:schemeClr>
                  </a:solidFill>
                  <a:prstDash val="solid"/>
                  <a:miter lim="800000"/>
                </a:ln>
                <a:noFill/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</a:t>
            </a:r>
            <a:r>
              <a:rPr lang="en-US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Q+</a:t>
            </a:r>
            <a:r>
              <a:rPr lang="en-US" dirty="0" smtClean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16956" y="5584763"/>
            <a:ext cx="898633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Clr>
                <a:srgbClr val="FF0000"/>
              </a:buClr>
            </a:pPr>
            <a:r>
              <a:rPr lang="en-US" altLang="zh-CN" dirty="0" smtClean="0"/>
              <a:t>Additional </a:t>
            </a:r>
            <a:r>
              <a:rPr lang="en-US" altLang="zh-CN" smtClean="0"/>
              <a:t>file </a:t>
            </a:r>
            <a:r>
              <a:rPr lang="en-US" altLang="zh-CN" smtClean="0"/>
              <a:t>13: </a:t>
            </a:r>
            <a:r>
              <a:rPr lang="en-US" altLang="zh-CN" dirty="0" smtClean="0"/>
              <a:t>Flow chart of overall experimental design.</a:t>
            </a:r>
            <a:endParaRPr lang="en-US" altLang="zh-CN" dirty="0"/>
          </a:p>
        </p:txBody>
      </p:sp>
      <p:sp>
        <p:nvSpPr>
          <p:cNvPr id="7" name="Rounded Rectangle 6"/>
          <p:cNvSpPr/>
          <p:nvPr/>
        </p:nvSpPr>
        <p:spPr>
          <a:xfrm rot="16200000">
            <a:off x="6250654" y="-348472"/>
            <a:ext cx="571500" cy="3843591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eaVert" rtlCol="0" anchor="ctr"/>
          <a:lstStyle/>
          <a:p>
            <a:pPr algn="ctr">
              <a:spcBef>
                <a:spcPts val="600"/>
              </a:spcBef>
            </a:pP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62 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ybean 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proved lines</a:t>
            </a:r>
          </a:p>
        </p:txBody>
      </p:sp>
      <p:sp>
        <p:nvSpPr>
          <p:cNvPr id="24" name="Rounded Rectangle 23"/>
          <p:cNvSpPr/>
          <p:nvPr/>
        </p:nvSpPr>
        <p:spPr>
          <a:xfrm rot="16200000">
            <a:off x="2114550" y="-359668"/>
            <a:ext cx="571500" cy="3886200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vert="eaVert" rtlCol="0" anchor="ctr"/>
          <a:lstStyle/>
          <a:p>
            <a:pPr algn="ctr">
              <a:spcBef>
                <a:spcPts val="600"/>
              </a:spcBef>
            </a:pP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42 Soybean landraces</a:t>
            </a: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5167325" y="1877737"/>
            <a:ext cx="0" cy="401564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3657600" y="1877737"/>
            <a:ext cx="0" cy="400735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3733800" y="1877737"/>
            <a:ext cx="945149" cy="362586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H="1">
            <a:off x="4191002" y="1877737"/>
            <a:ext cx="976323" cy="36209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7" name="Rounded Rectangle 36"/>
          <p:cNvSpPr/>
          <p:nvPr/>
        </p:nvSpPr>
        <p:spPr>
          <a:xfrm>
            <a:off x="3352801" y="3259016"/>
            <a:ext cx="1981199" cy="561877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pmap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otypic data (</a:t>
            </a:r>
            <a:r>
              <a:rPr lang="en-US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ounded Rectangle 38"/>
          <p:cNvSpPr/>
          <p:nvPr/>
        </p:nvSpPr>
        <p:spPr>
          <a:xfrm>
            <a:off x="7086600" y="3259017"/>
            <a:ext cx="1371600" cy="561876"/>
          </a:xfrm>
          <a:prstGeom prst="roundRect">
            <a:avLst/>
          </a:prstGeom>
          <a:ln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nship analysis (</a:t>
            </a:r>
            <a:r>
              <a:rPr lang="en-US" b="1" dirty="0" smtClean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ounded Rectangle 40"/>
          <p:cNvSpPr/>
          <p:nvPr/>
        </p:nvSpPr>
        <p:spPr>
          <a:xfrm>
            <a:off x="457201" y="3259016"/>
            <a:ext cx="2743199" cy="553704"/>
          </a:xfrm>
          <a:prstGeom prst="round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enotype data of  9 agronomic traits (</a:t>
            </a:r>
            <a:r>
              <a:rPr lang="en-US" dirty="0" smtClean="0">
                <a:ln w="18000">
                  <a:solidFill>
                    <a:schemeClr val="accent2">
                      <a:satMod val="140000"/>
                    </a:schemeClr>
                  </a:solidFill>
                  <a:prstDash val="solid"/>
                  <a:miter lim="800000"/>
                </a:ln>
                <a:noFill/>
                <a:latin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Rounded Rectangle 41"/>
          <p:cNvSpPr/>
          <p:nvPr/>
        </p:nvSpPr>
        <p:spPr>
          <a:xfrm>
            <a:off x="5514968" y="3259016"/>
            <a:ext cx="1419232" cy="561878"/>
          </a:xfrm>
          <a:prstGeom prst="roundRect">
            <a:avLst/>
          </a:prstGeom>
          <a:ln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pulation structure(Q)</a:t>
            </a:r>
            <a:endParaRPr 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4873543" y="2915066"/>
            <a:ext cx="0" cy="30480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2885748" y="2935553"/>
            <a:ext cx="0" cy="30480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6316834" y="2915066"/>
            <a:ext cx="0" cy="30480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7845343" y="2954215"/>
            <a:ext cx="0" cy="304800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2916329" y="3853550"/>
            <a:ext cx="0" cy="478737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3505200" y="3851188"/>
            <a:ext cx="0" cy="481099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>
            <a:off x="3733800" y="3874852"/>
            <a:ext cx="1890726" cy="39379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 flipH="1">
            <a:off x="4114803" y="3853550"/>
            <a:ext cx="3210196" cy="478737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4679023" y="3858839"/>
            <a:ext cx="1671891" cy="409811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5"/>
          </a:lnRef>
          <a:fillRef idx="0">
            <a:schemeClr val="accent5"/>
          </a:fillRef>
          <a:effectRef idx="0">
            <a:schemeClr val="accent5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>
            <a:stCxn id="19" idx="1"/>
          </p:cNvCxnSpPr>
          <p:nvPr/>
        </p:nvCxnSpPr>
        <p:spPr>
          <a:xfrm flipH="1">
            <a:off x="4159720" y="4627452"/>
            <a:ext cx="1707679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Oval 114"/>
          <p:cNvSpPr/>
          <p:nvPr/>
        </p:nvSpPr>
        <p:spPr>
          <a:xfrm>
            <a:off x="3962401" y="4475586"/>
            <a:ext cx="1904998" cy="619127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Validated by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374746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</TotalTime>
  <Words>69</Words>
  <Application>Microsoft Office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S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viewer</dc:creator>
  <cp:lastModifiedBy>Real, Francis Frank</cp:lastModifiedBy>
  <cp:revision>17</cp:revision>
  <dcterms:created xsi:type="dcterms:W3CDTF">2015-07-02T02:52:58Z</dcterms:created>
  <dcterms:modified xsi:type="dcterms:W3CDTF">2015-08-28T20:17:06Z</dcterms:modified>
</cp:coreProperties>
</file>